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3" autoAdjust="0"/>
    <p:restoredTop sz="94660"/>
  </p:normalViewPr>
  <p:slideViewPr>
    <p:cSldViewPr snapToGrid="0">
      <p:cViewPr varScale="1">
        <p:scale>
          <a:sx n="67" d="100"/>
          <a:sy n="67" d="100"/>
        </p:scale>
        <p:origin x="568" y="-1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97BE85-CEC6-4B90-8AB2-979ADF5FAAD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C311810-D31E-4EC2-B3AD-2B09B8403E6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DB1E1CD-DC6E-405B-8564-48EFE6F391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2F85A-C52E-4094-8B36-FB560125B977}" type="datetimeFigureOut">
              <a:rPr lang="en-US" smtClean="0"/>
              <a:t>6/1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BFA4CE-2021-4934-A910-47CE206C4C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C0C632-666F-416E-905A-B1F1551ED5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8877ED-CA99-4E0D-A7CB-70CF0039C1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78302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7555AC-3A52-4A75-A822-893FBFA393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23A990E-845B-4F04-9AEE-7D3CEBCF70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C1A662-6DDE-4D3D-BA35-F1C70387AC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2F85A-C52E-4094-8B36-FB560125B977}" type="datetimeFigureOut">
              <a:rPr lang="en-US" smtClean="0"/>
              <a:t>6/1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3CCE19-51AB-4DD5-935E-40110792A6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2235544-3ECE-4D52-B028-7087395A38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8877ED-CA99-4E0D-A7CB-70CF0039C1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1011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18BF104-AB37-4661-8ED2-4A68A9B1625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8FA960E-BD97-46FB-ACC1-6EEC6939864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F94CC4-6923-4F6E-9A06-0D7F06C217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2F85A-C52E-4094-8B36-FB560125B977}" type="datetimeFigureOut">
              <a:rPr lang="en-US" smtClean="0"/>
              <a:t>6/1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4463414-8794-40E6-821E-6708DA7AB5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FF0E79-36C3-4849-B282-AD77DF699F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8877ED-CA99-4E0D-A7CB-70CF0039C1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32961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9F6393-FB0C-46A8-BE46-AA0D7288EE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632FEF-1460-4419-B9BA-117F6C89444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7BA738-BD88-4BC0-A8F5-13CAA7A889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2F85A-C52E-4094-8B36-FB560125B977}" type="datetimeFigureOut">
              <a:rPr lang="en-US" smtClean="0"/>
              <a:t>6/1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6600A5-8CE4-4C94-BC2F-489ACE2F38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F89C49-E5D6-4F48-A440-EE367D0028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8877ED-CA99-4E0D-A7CB-70CF0039C1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26574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81DB45-D861-4ECC-BB55-D860242669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3F0263-E904-4614-B5B0-E9ED79E251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55F2AB-25ED-4A92-A7A5-3D56B80611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2F85A-C52E-4094-8B36-FB560125B977}" type="datetimeFigureOut">
              <a:rPr lang="en-US" smtClean="0"/>
              <a:t>6/1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391302-A6C3-4119-8553-3A5E49E9FD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558516-40F7-4958-A3C5-6B3DFA842E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8877ED-CA99-4E0D-A7CB-70CF0039C1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8046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2A81A6-F23C-4DD2-85E6-65E3B4E4C1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4164CED-10B4-4247-9F7D-0837509B75D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7EF3201-C670-41B9-9D78-3030867D61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72CAD5A-46F0-4E29-843E-6944FB45C3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2F85A-C52E-4094-8B36-FB560125B977}" type="datetimeFigureOut">
              <a:rPr lang="en-US" smtClean="0"/>
              <a:t>6/1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73E8BAC-707B-4780-9EA1-1762A33549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607DAF8-BF2C-4623-A367-0A98304723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8877ED-CA99-4E0D-A7CB-70CF0039C1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53717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790AB7-A38B-4998-9B76-32EDDB2D55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6536E2-88D1-44AB-8D6F-9E5CEA140B0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CC906A4-F4CA-4D2F-A7BE-8A73FA9391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2A2A0A9-9825-4AFE-92A3-A31D5237CB5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29EEF07-EAE2-4E36-9823-7962B3E2AB4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B6EC7A6-8D90-4C4C-AB9C-6B2B0F08BB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2F85A-C52E-4094-8B36-FB560125B977}" type="datetimeFigureOut">
              <a:rPr lang="en-US" smtClean="0"/>
              <a:t>6/10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89F20C1-35B6-49C2-9AC7-6AA7860105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B4A97D3-252F-4CB6-B421-A94A7648C7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8877ED-CA99-4E0D-A7CB-70CF0039C1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01763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D468B3-52A1-4320-AAD7-32FE60C1F9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57B533A-B699-44BB-9DC6-992380D63C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2F85A-C52E-4094-8B36-FB560125B977}" type="datetimeFigureOut">
              <a:rPr lang="en-US" smtClean="0"/>
              <a:t>6/10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C256759-4363-40D1-81D5-E74D1581BC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5516ED4-00FB-4480-800F-BBDA063F33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8877ED-CA99-4E0D-A7CB-70CF0039C1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7812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7C0603B-A348-4C6B-BF7A-8A2B1ACCAD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2F85A-C52E-4094-8B36-FB560125B977}" type="datetimeFigureOut">
              <a:rPr lang="en-US" smtClean="0"/>
              <a:t>6/10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DDF5955-9BD4-4DC6-ABE8-2C878FB73B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91599D9-A2EC-4ADE-B55E-AA693156B3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8877ED-CA99-4E0D-A7CB-70CF0039C1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53199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4DABD0-42BE-4243-937E-F9B5E400D9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B3154B-0372-4F55-9625-C258D472F61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9CD035F-1871-4750-91F7-4560A98E758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CEEB725-7596-422F-B560-B2D8CD7D78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2F85A-C52E-4094-8B36-FB560125B977}" type="datetimeFigureOut">
              <a:rPr lang="en-US" smtClean="0"/>
              <a:t>6/1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77F8C4E-69B8-49A6-901A-D6ACB5B7D5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27F6A1-0093-4B5D-86C6-729164A6A0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8877ED-CA99-4E0D-A7CB-70CF0039C1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88780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88C35E-8F15-41AB-AF20-41F765125D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28C5CE6-98BF-4749-BA85-80F8D8760A7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E6FBA52-7109-42F9-9808-C99273D57BD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F8D9F9-734B-44D1-BC35-AD2AE29982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72F85A-C52E-4094-8B36-FB560125B977}" type="datetimeFigureOut">
              <a:rPr lang="en-US" smtClean="0"/>
              <a:t>6/1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5FEF59D-1391-42A1-A2B4-5A36DF9BE7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8AF3F08-00BE-483E-9DB2-75CB7B87BA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8877ED-CA99-4E0D-A7CB-70CF0039C1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4158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FBBE008-7F5B-4C56-B960-61197183A8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0E48A2-F79C-4BFC-8F40-8ADCF49158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BA6C425-DD55-45E6-B950-D6E2429241D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72F85A-C52E-4094-8B36-FB560125B977}" type="datetimeFigureOut">
              <a:rPr lang="en-US" smtClean="0"/>
              <a:t>6/1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949EF3-73B6-4B7C-AA3C-6280295EE23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33A61F-1FAE-4FBA-BE5F-25EA05FBDB5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8877ED-CA99-4E0D-A7CB-70CF0039C1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60224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CF89850-90A5-4AA0-B64D-F9DDEC27120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0208" y="253312"/>
            <a:ext cx="2210000" cy="215794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F136E22-8860-4ECF-AC7B-CB190B95764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21542" y="270384"/>
            <a:ext cx="2210000" cy="215794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D87236B-360F-46B1-B73D-E73F496BE00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31542" y="115525"/>
            <a:ext cx="2210000" cy="219209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44D16F74-2529-4F70-BC10-6BE6463EBDD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30777" y="147463"/>
            <a:ext cx="2155264" cy="2280869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5CE8AA8D-C000-4426-A0F1-EE9DAC381F0E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075276" y="54064"/>
            <a:ext cx="2107369" cy="2315013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7C404A62-375F-4DAA-945F-5AB1F65282F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914904" y="2661111"/>
            <a:ext cx="3537515" cy="1771891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53EF5D4A-1609-4548-B62B-9CF1BC368B09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154570" y="2661111"/>
            <a:ext cx="1760334" cy="172471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9DA0737-036B-47A9-89F9-A67138821F8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18385" y="4786496"/>
            <a:ext cx="5293926" cy="1779374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180208" y="6565870"/>
            <a:ext cx="992132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Flow cytometric gating strategy for T-cell, B-cell, and monocyte analysis</a:t>
            </a:r>
          </a:p>
        </p:txBody>
      </p:sp>
    </p:spTree>
    <p:extLst>
      <p:ext uri="{BB962C8B-B14F-4D97-AF65-F5344CB8AC3E}">
        <p14:creationId xmlns:p14="http://schemas.microsoft.com/office/powerpoint/2010/main" val="9499746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CF89850-90A5-4AA0-B64D-F9DDEC27120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0208" y="253312"/>
            <a:ext cx="2210000" cy="215794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1F136E22-8860-4ECF-AC7B-CB190B95764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21542" y="270384"/>
            <a:ext cx="2210000" cy="215794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D87236B-360F-46B1-B73D-E73F496BE00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31542" y="115525"/>
            <a:ext cx="2210000" cy="2192092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44D16F74-2529-4F70-BC10-6BE6463EBDD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026058" y="115525"/>
            <a:ext cx="2155264" cy="2280869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E26D2040-E559-4D7D-98E4-2E409A631EE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465838" y="191851"/>
            <a:ext cx="2182632" cy="22808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421493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16</Words>
  <Application>Microsoft Office PowerPoint</Application>
  <PresentationFormat>Widescreen</PresentationFormat>
  <Paragraphs>1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lic, Alina</dc:creator>
  <cp:lastModifiedBy>Eleanor Masterman</cp:lastModifiedBy>
  <cp:revision>5</cp:revision>
  <dcterms:created xsi:type="dcterms:W3CDTF">2020-04-25T00:54:16Z</dcterms:created>
  <dcterms:modified xsi:type="dcterms:W3CDTF">2021-06-10T16:10:40Z</dcterms:modified>
</cp:coreProperties>
</file>